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90"/>
    <p:restoredTop sz="94694"/>
  </p:normalViewPr>
  <p:slideViewPr>
    <p:cSldViewPr snapToGrid="0" showGuides="1">
      <p:cViewPr varScale="1">
        <p:scale>
          <a:sx n="117" d="100"/>
          <a:sy n="117" d="100"/>
        </p:scale>
        <p:origin x="256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76430E-9651-BF47-B6C8-135CC1C4DC9A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8B88CE-74A4-744B-B37D-E0EF5F5749BF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3809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88B88CE-74A4-744B-B37D-E0EF5F5749BF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435083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16C8868-E1E5-2926-438A-356DBFC337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64BA066-A59B-A169-4D7F-5D2CD5ADD3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CA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8823A43-64BD-79E3-016F-6B4A42DBB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D21135C-DEBC-459B-9AA7-B0278BF28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5D36BE5-37CE-0AC7-B264-19BDFEB99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11014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0BB4478-8B75-7677-7F18-3472C0925C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A37B47A-98D4-1C91-E4BC-8D56F2C8A3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5263EAA-54B0-F255-B73A-65EC6758C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754CC97-E78F-6B5D-3816-AD00A5D7C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25BD2F9-9F8E-1165-DD82-7285E43FC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3516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CC2BDB0-C9EB-636F-3BBC-3097104546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E5B5807-0683-5D9D-E669-71C5907EFA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FC92D22-3316-05A1-6D69-51093EA3A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4BF9E0C-278A-1CDD-4ABB-19F800167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83E751-6DB7-8E4E-04E6-AB56905D9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2731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3E0A03-6DDF-69EA-C601-988C2049AA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4645B88-8DC6-1D07-E74F-F21F2AABEE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CB536B1-D697-C785-5D71-8590BC7BE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77B077B-E7DC-33FA-1DA9-11F0A549D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975520-CDC9-94F3-E32C-414C697DF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1963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FA3E7E-F52E-68E0-6B0C-1BB8883B3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C4EF04A-37F1-398E-3291-E818E1CF11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FA7E9B2-B886-434B-D4D5-081B4FCA2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9B16D50-BAA6-F1EC-2572-6AC593FA6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FE439E4-A770-4C4F-8677-4DEC0B662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97334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D980BA-C491-3E23-ACC2-949E02800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5A0F8E4-B8A5-94DC-A02B-12634D1431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8C0CDEC-A8FA-A50A-1C7A-3C47DDC21F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87629E-198D-BFF6-DE4E-A4DD27500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AF4F975-22FC-AA31-7801-C6B5BC44A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1BB7375-6694-733D-58D6-CD430EA03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54422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FFFBB0E-604F-ED11-3A8B-A151C0888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9B97817-825E-ADE4-57F8-C7743E4F6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C248EEE-9ED1-3C7C-34C4-5B33861AF0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BE57872-328B-84BB-9DA5-1DFDC90F0A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4138CEB-76AF-FC0B-B75E-2528756AF0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D612994-165C-B2CD-86C3-312A4BC00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2BE9C69-EB41-6298-6D81-08FD71E66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25F69D9-DCAD-69AA-4D0A-DE3F6AC3A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7347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5219DB-BFC5-290F-ABEC-BA4F2193A5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6FF6280-F2C1-E836-F1DD-D932F6887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AD8801F5-63EC-5185-4D12-0BB146304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0690856-4336-8CCA-7E99-8840EC239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60177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C6BF90C-9831-DC09-41B6-D768205ED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4AA5C95-437F-398B-EA1C-A4D7CA87F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7EB09A8-421F-7A9F-728F-8991DEBD3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8911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95F4105-A340-A60B-353E-F4D0FBE7A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2D6878-DF03-43EE-916E-7E114E3A50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2F02EB8-9E0C-760E-92B4-29E2441B1E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AF9AF2-E0BC-4709-E11D-107D525DF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C1AD699-EB8B-51A5-9198-6E5AB3A60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888E970-47FD-25FD-F3A4-6ED38B9BD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90528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FFA9D9-95B7-F51E-FA1C-AD0512CDDA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E0F3B0A-0A97-5530-81C5-AB55D92CD9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8B0DE2C-8779-C1CD-AF25-5C033C6141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351CF72-04BC-B945-8255-E922C12D2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E767D46-6D93-05E5-88B2-BA9457A82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7C6DBF0-BD54-B358-1B4F-72FC3578B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04012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DDC4D284-F136-FC1A-C9D0-9A8432204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CA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587376E-8C15-2229-C952-E75720C785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CA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938512B-3EF6-68D2-7E06-5F0A95F8C7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C55612-1711-7648-8A03-59B5504B0DD3}" type="datetimeFigureOut">
              <a:rPr lang="en-CA" smtClean="0"/>
              <a:t>2025-04-23</a:t>
            </a:fld>
            <a:endParaRPr lang="en-CA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591730-B58C-C1B3-2329-F02115376C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6DF4F97-6BF0-E8B9-8769-6B923B51C0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358EAF-B91A-994E-9679-376C3D286998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06696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D7DA9E4D-38C3-ECC8-899D-C4F20B7FB0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25942"/>
            <a:ext cx="12115161" cy="464571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C968768-36D2-15AC-B2C9-EB5540A64EFA}"/>
              </a:ext>
            </a:extLst>
          </p:cNvPr>
          <p:cNvSpPr txBox="1"/>
          <p:nvPr/>
        </p:nvSpPr>
        <p:spPr>
          <a:xfrm>
            <a:off x="486697" y="5662726"/>
            <a:ext cx="619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1. </a:t>
            </a:r>
            <a:r>
              <a:rPr lang="en-CA" dirty="0">
                <a:latin typeface="PT Sans" panose="020B0503020203020204" pitchFamily="34" charset="77"/>
              </a:rPr>
              <a:t>Inference statistics (SPM) regarding ankle in frontal plane.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50467F7A-7A7C-0B79-6FC1-1BE9399CB327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97112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6A2B74-306C-660C-3461-3D2EBB10FE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0C0D0D12-C642-2978-5CC4-109D8C9F1B6C}"/>
              </a:ext>
            </a:extLst>
          </p:cNvPr>
          <p:cNvSpPr txBox="1"/>
          <p:nvPr/>
        </p:nvSpPr>
        <p:spPr>
          <a:xfrm>
            <a:off x="486697" y="5662726"/>
            <a:ext cx="6330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2. </a:t>
            </a:r>
            <a:r>
              <a:rPr lang="en-CA" dirty="0">
                <a:latin typeface="PT Sans" panose="020B0503020203020204" pitchFamily="34" charset="77"/>
              </a:rPr>
              <a:t>Inference statistics (SPM) regarding ankle in sagittal plane.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C98C3DAF-FE6F-CFD9-619A-3A0CA5DB0D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92820"/>
            <a:ext cx="11830046" cy="4536379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AA5A183-879C-04A9-4853-9A81D07B4FB7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4224810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5B832F4-1A9D-6B98-9A1A-E5D020413B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99ADEB2A-3A89-9B37-B7F3-7EECE0684019}"/>
              </a:ext>
            </a:extLst>
          </p:cNvPr>
          <p:cNvSpPr txBox="1"/>
          <p:nvPr/>
        </p:nvSpPr>
        <p:spPr>
          <a:xfrm>
            <a:off x="486697" y="5662726"/>
            <a:ext cx="6675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3. </a:t>
            </a:r>
            <a:r>
              <a:rPr lang="en-CA" dirty="0">
                <a:latin typeface="PT Sans" panose="020B0503020203020204" pitchFamily="34" charset="77"/>
              </a:rPr>
              <a:t>Inference statistics (SPM) regarding ankle in transversal plane.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553F34FC-785B-F00E-FA49-BD3CADB5B1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92820"/>
            <a:ext cx="11830046" cy="4536379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60D0711F-EB0C-9098-C549-6D82E00109CC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583442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AE0F36-47B9-49FD-B9AD-DBA72A3C7D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37E4AEA4-6CF8-B2A1-A1EA-BF7B5FC0D9A0}"/>
              </a:ext>
            </a:extLst>
          </p:cNvPr>
          <p:cNvSpPr txBox="1"/>
          <p:nvPr/>
        </p:nvSpPr>
        <p:spPr>
          <a:xfrm>
            <a:off x="486697" y="5662726"/>
            <a:ext cx="6143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4. </a:t>
            </a:r>
            <a:r>
              <a:rPr lang="en-CA" dirty="0">
                <a:latin typeface="PT Sans" panose="020B0503020203020204" pitchFamily="34" charset="77"/>
              </a:rPr>
              <a:t>Inference statistics (SPM) regarding knee in front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9F862869-34B5-F4E2-6057-E4B9C5371B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285" y="507569"/>
            <a:ext cx="11945429" cy="4580624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15ABFC2B-2B57-DB63-567C-9C782D7A0CD7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118739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D1BEB3-9466-E97C-5D18-FE2681C515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979C11A3-5124-BDB8-FA06-A351C6A1951C}"/>
              </a:ext>
            </a:extLst>
          </p:cNvPr>
          <p:cNvSpPr txBox="1"/>
          <p:nvPr/>
        </p:nvSpPr>
        <p:spPr>
          <a:xfrm>
            <a:off x="486697" y="5662726"/>
            <a:ext cx="6216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5. </a:t>
            </a:r>
            <a:r>
              <a:rPr lang="en-CA" dirty="0">
                <a:latin typeface="PT Sans" panose="020B0503020203020204" pitchFamily="34" charset="77"/>
              </a:rPr>
              <a:t>Inference statistics (SPM) regarding knee in sagitt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59150711-0E31-15F1-073D-7F0346FE91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988" y="427734"/>
            <a:ext cx="11692092" cy="4483479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F14FB41B-33CB-0966-6C09-2BD403750B89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8069856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4A4655-E071-A37E-7662-F081527ACF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57A78AE6-A69E-9613-D6E3-8057016A950C}"/>
              </a:ext>
            </a:extLst>
          </p:cNvPr>
          <p:cNvSpPr txBox="1"/>
          <p:nvPr/>
        </p:nvSpPr>
        <p:spPr>
          <a:xfrm>
            <a:off x="486697" y="5662726"/>
            <a:ext cx="6561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6. </a:t>
            </a:r>
            <a:r>
              <a:rPr lang="en-CA" dirty="0">
                <a:latin typeface="PT Sans" panose="020B0503020203020204" pitchFamily="34" charset="77"/>
              </a:rPr>
              <a:t>Inference statistics (SPM) regarding knee in transvers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E386C788-0A80-D656-7836-F945AA21D1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986" y="448576"/>
            <a:ext cx="11983889" cy="4595372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261357C0-CC8E-7A71-4897-88CF1981F81A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8950073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BA0893-5483-E5CF-B4C8-0C6AF481E2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0F7F36A4-E496-EFFD-BA47-7AF24B0D2AAF}"/>
              </a:ext>
            </a:extLst>
          </p:cNvPr>
          <p:cNvSpPr txBox="1"/>
          <p:nvPr/>
        </p:nvSpPr>
        <p:spPr>
          <a:xfrm>
            <a:off x="486697" y="5662726"/>
            <a:ext cx="5958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7. </a:t>
            </a:r>
            <a:r>
              <a:rPr lang="en-CA" dirty="0">
                <a:latin typeface="PT Sans" panose="020B0503020203020204" pitchFamily="34" charset="77"/>
              </a:rPr>
              <a:t>Inference statistics (SPM) regarding hip in front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56A69199-DB84-BE5E-4B1E-DA4451AC81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728" y="339243"/>
            <a:ext cx="12038243" cy="4616215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55551DA7-46FD-FAF5-C54D-EEBF2349A64E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0012001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18C63E-E21B-B426-FA3B-B749093D47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B66E5CEF-DF40-83A4-A8D2-3C8B5E7AF556}"/>
              </a:ext>
            </a:extLst>
          </p:cNvPr>
          <p:cNvSpPr txBox="1"/>
          <p:nvPr/>
        </p:nvSpPr>
        <p:spPr>
          <a:xfrm>
            <a:off x="486697" y="5662726"/>
            <a:ext cx="6240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8. </a:t>
            </a:r>
            <a:r>
              <a:rPr lang="en-CA" dirty="0">
                <a:latin typeface="PT Sans" panose="020B0503020203020204" pitchFamily="34" charset="77"/>
              </a:rPr>
              <a:t>Inference statistics (SPM) regarding hip in sagitt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DC100981-206E-A437-B642-97FA849285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0250"/>
            <a:ext cx="12230544" cy="4689955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26451337-2911-ED9A-A0DA-401364C88A2C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285047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EE25A1-C0C2-18E2-B8E7-AA0101F91B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2E0E0BDE-E058-A4F3-EB73-6C0583E90592}"/>
              </a:ext>
            </a:extLst>
          </p:cNvPr>
          <p:cNvSpPr txBox="1"/>
          <p:nvPr/>
        </p:nvSpPr>
        <p:spPr>
          <a:xfrm>
            <a:off x="486697" y="5662726"/>
            <a:ext cx="65855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b="1" dirty="0">
                <a:latin typeface="PT Sans" panose="020B0503020203020204" pitchFamily="34" charset="77"/>
              </a:rPr>
              <a:t>S9. </a:t>
            </a:r>
            <a:r>
              <a:rPr lang="en-CA" dirty="0">
                <a:latin typeface="PT Sans" panose="020B0503020203020204" pitchFamily="34" charset="77"/>
              </a:rPr>
              <a:t>Inference statistics (SPM) regarding hip in transversal plane.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D8DC47E1-D538-934B-5B31-E15E066F20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80250"/>
            <a:ext cx="12153624" cy="4660459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62682633-FE26-8EBB-838A-054F3DE472B4}"/>
              </a:ext>
            </a:extLst>
          </p:cNvPr>
          <p:cNvSpPr txBox="1"/>
          <p:nvPr/>
        </p:nvSpPr>
        <p:spPr>
          <a:xfrm>
            <a:off x="486697" y="6044316"/>
            <a:ext cx="115376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de-DE" sz="1200" dirty="0">
                <a:effectLst/>
                <a:latin typeface="PT Sans" panose="020B0503020203020204" pitchFamily="34" charset="77"/>
              </a:rPr>
              <a:t>Statistical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igni</a:t>
            </a:r>
            <a:r>
              <a:rPr lang="de-DE" sz="1200" dirty="0" err="1">
                <a:latin typeface="PT Sans" panose="020B0503020203020204" pitchFamily="34" charset="77"/>
              </a:rPr>
              <a:t>fi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canc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s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SPM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exceeds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hreshol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(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dot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line</a:t>
            </a:r>
            <a:r>
              <a:rPr lang="de-DE" sz="1200" dirty="0">
                <a:effectLst/>
                <a:latin typeface="PT Sans" panose="020B0503020203020204" pitchFamily="34" charset="77"/>
              </a:rPr>
              <a:t>)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present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ay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had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areas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Colors: Time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of</a:t>
            </a:r>
            <a:r>
              <a:rPr lang="de-DE" sz="1200" dirty="0">
                <a:effectLst/>
                <a:latin typeface="PT Sans" panose="020B0503020203020204" pitchFamily="34" charset="77"/>
              </a:rPr>
              <a:t>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measurement</a:t>
            </a:r>
            <a:r>
              <a:rPr lang="de-DE" sz="1200" dirty="0">
                <a:effectLst/>
                <a:latin typeface="PT Sans" panose="020B0503020203020204" pitchFamily="34" charset="77"/>
              </a:rPr>
              <a:t>:</a:t>
            </a:r>
          </a:p>
          <a:p>
            <a:pPr>
              <a:buNone/>
            </a:pP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-test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post-test;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interventions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SMFO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BMFO; Interaction Intervention ×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ToM</a:t>
            </a:r>
            <a:r>
              <a:rPr lang="de-DE" sz="1200" dirty="0">
                <a:effectLst/>
                <a:latin typeface="PT Sans" panose="020B0503020203020204" pitchFamily="34" charset="77"/>
              </a:rPr>
              <a:t>: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yellow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</a:t>
            </a:r>
          </a:p>
          <a:p>
            <a:r>
              <a:rPr lang="de-DE" sz="1200" dirty="0" err="1">
                <a:effectLst/>
                <a:latin typeface="PT Sans" panose="020B0503020203020204" pitchFamily="34" charset="77"/>
              </a:rPr>
              <a:t>green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S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red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re</a:t>
            </a:r>
            <a:r>
              <a:rPr lang="de-DE" sz="1200" dirty="0">
                <a:effectLst/>
                <a:latin typeface="PT Sans" panose="020B0503020203020204" pitchFamily="34" charset="77"/>
              </a:rPr>
              <a:t>,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 = 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BMFO_post</a:t>
            </a:r>
            <a:r>
              <a:rPr lang="de-DE" sz="1200" dirty="0">
                <a:effectLst/>
                <a:latin typeface="PT Sans" panose="020B0503020203020204" pitchFamily="34" charset="77"/>
              </a:rPr>
              <a:t>. Black: F-</a:t>
            </a:r>
            <a:r>
              <a:rPr lang="de-DE" sz="1200" dirty="0" err="1">
                <a:effectLst/>
                <a:latin typeface="PT Sans" panose="020B0503020203020204" pitchFamily="34" charset="77"/>
              </a:rPr>
              <a:t>value</a:t>
            </a:r>
            <a:r>
              <a:rPr lang="de-DE" sz="1200" dirty="0">
                <a:effectLst/>
                <a:latin typeface="PT Sans" panose="020B0503020203020204" pitchFamily="34" charset="77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801455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9</Words>
  <Application>Microsoft Macintosh PowerPoint</Application>
  <PresentationFormat>Breitbild</PresentationFormat>
  <Paragraphs>37</Paragraphs>
  <Slides>9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PT Sans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ven </dc:creator>
  <cp:lastModifiedBy>Steven </cp:lastModifiedBy>
  <cp:revision>2</cp:revision>
  <dcterms:created xsi:type="dcterms:W3CDTF">2025-04-23T06:54:52Z</dcterms:created>
  <dcterms:modified xsi:type="dcterms:W3CDTF">2025-04-23T07:03:18Z</dcterms:modified>
</cp:coreProperties>
</file>